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695" autoAdjust="0"/>
    <p:restoredTop sz="94660"/>
  </p:normalViewPr>
  <p:slideViewPr>
    <p:cSldViewPr snapToGrid="0">
      <p:cViewPr>
        <p:scale>
          <a:sx n="51" d="100"/>
          <a:sy n="51" d="100"/>
        </p:scale>
        <p:origin x="1716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ichger, Havovi" userId="598738d1-3ba5-4686-aed1-a57cae5413b5" providerId="ADAL" clId="{CC0DB65A-7488-4019-AA38-4947FC8E5ACD}"/>
    <pc:docChg chg="modSld">
      <pc:chgData name="Chichger, Havovi" userId="598738d1-3ba5-4686-aed1-a57cae5413b5" providerId="ADAL" clId="{CC0DB65A-7488-4019-AA38-4947FC8E5ACD}" dt="2025-11-07T14:24:23.337" v="258" actId="20577"/>
      <pc:docMkLst>
        <pc:docMk/>
      </pc:docMkLst>
      <pc:sldChg chg="modSp mod">
        <pc:chgData name="Chichger, Havovi" userId="598738d1-3ba5-4686-aed1-a57cae5413b5" providerId="ADAL" clId="{CC0DB65A-7488-4019-AA38-4947FC8E5ACD}" dt="2025-11-07T14:24:23.337" v="258" actId="20577"/>
        <pc:sldMkLst>
          <pc:docMk/>
          <pc:sldMk cId="2795855234" sldId="256"/>
        </pc:sldMkLst>
        <pc:spChg chg="mod">
          <ac:chgData name="Chichger, Havovi" userId="598738d1-3ba5-4686-aed1-a57cae5413b5" providerId="ADAL" clId="{CC0DB65A-7488-4019-AA38-4947FC8E5ACD}" dt="2025-11-07T14:24:16.957" v="242" actId="14100"/>
          <ac:spMkLst>
            <pc:docMk/>
            <pc:sldMk cId="2795855234" sldId="256"/>
            <ac:spMk id="10" creationId="{CE75EA26-D31C-681F-379A-CE0DFF2CDC4F}"/>
          </ac:spMkLst>
        </pc:spChg>
        <pc:spChg chg="mod">
          <ac:chgData name="Chichger, Havovi" userId="598738d1-3ba5-4686-aed1-a57cae5413b5" providerId="ADAL" clId="{CC0DB65A-7488-4019-AA38-4947FC8E5ACD}" dt="2025-11-07T14:24:23.337" v="258" actId="20577"/>
          <ac:spMkLst>
            <pc:docMk/>
            <pc:sldMk cId="2795855234" sldId="256"/>
            <ac:spMk id="11" creationId="{3D523DD2-1A23-6560-A2A1-3E21E09AD281}"/>
          </ac:spMkLst>
        </pc:spChg>
        <pc:spChg chg="mod">
          <ac:chgData name="Chichger, Havovi" userId="598738d1-3ba5-4686-aed1-a57cae5413b5" providerId="ADAL" clId="{CC0DB65A-7488-4019-AA38-4947FC8E5ACD}" dt="2025-11-07T14:24:04.436" v="223" actId="1076"/>
          <ac:spMkLst>
            <pc:docMk/>
            <pc:sldMk cId="2795855234" sldId="256"/>
            <ac:spMk id="14" creationId="{F6298F77-965B-8FE4-EC41-FDA9B30004C0}"/>
          </ac:spMkLst>
        </pc:spChg>
      </pc:sldChg>
    </pc:docChg>
  </pc:docChgLst>
  <pc:docChgLst>
    <pc:chgData name="Chichger, Havovi" userId="598738d1-3ba5-4686-aed1-a57cae5413b5" providerId="ADAL" clId="{F3F7A84D-7CA1-42FF-889A-50DC00948B63}"/>
    <pc:docChg chg="undo custSel modSld">
      <pc:chgData name="Chichger, Havovi" userId="598738d1-3ba5-4686-aed1-a57cae5413b5" providerId="ADAL" clId="{F3F7A84D-7CA1-42FF-889A-50DC00948B63}" dt="2025-10-17T07:34:34.837" v="385" actId="14100"/>
      <pc:docMkLst>
        <pc:docMk/>
      </pc:docMkLst>
      <pc:sldChg chg="addSp modSp mod setBg">
        <pc:chgData name="Chichger, Havovi" userId="598738d1-3ba5-4686-aed1-a57cae5413b5" providerId="ADAL" clId="{F3F7A84D-7CA1-42FF-889A-50DC00948B63}" dt="2025-10-17T07:34:34.837" v="385" actId="14100"/>
        <pc:sldMkLst>
          <pc:docMk/>
          <pc:sldMk cId="2795855234" sldId="256"/>
        </pc:sldMkLst>
        <pc:spChg chg="add mod">
          <ac:chgData name="Chichger, Havovi" userId="598738d1-3ba5-4686-aed1-a57cae5413b5" providerId="ADAL" clId="{F3F7A84D-7CA1-42FF-889A-50DC00948B63}" dt="2025-10-17T07:32:11.228" v="277" actId="404"/>
          <ac:spMkLst>
            <pc:docMk/>
            <pc:sldMk cId="2795855234" sldId="256"/>
            <ac:spMk id="8" creationId="{0FBB7439-8996-A3F8-5637-13A5484CD678}"/>
          </ac:spMkLst>
        </pc:spChg>
        <pc:spChg chg="add mod">
          <ac:chgData name="Chichger, Havovi" userId="598738d1-3ba5-4686-aed1-a57cae5413b5" providerId="ADAL" clId="{F3F7A84D-7CA1-42FF-889A-50DC00948B63}" dt="2025-10-17T07:32:24.388" v="283" actId="164"/>
          <ac:spMkLst>
            <pc:docMk/>
            <pc:sldMk cId="2795855234" sldId="256"/>
            <ac:spMk id="9" creationId="{161CD4FF-BDE5-35E9-775D-2E48F2EBBA12}"/>
          </ac:spMkLst>
        </pc:spChg>
        <pc:spChg chg="add mod">
          <ac:chgData name="Chichger, Havovi" userId="598738d1-3ba5-4686-aed1-a57cae5413b5" providerId="ADAL" clId="{F3F7A84D-7CA1-42FF-889A-50DC00948B63}" dt="2025-10-17T07:26:02.771" v="69" actId="113"/>
          <ac:spMkLst>
            <pc:docMk/>
            <pc:sldMk cId="2795855234" sldId="256"/>
            <ac:spMk id="10" creationId="{CE75EA26-D31C-681F-379A-CE0DFF2CDC4F}"/>
          </ac:spMkLst>
        </pc:spChg>
        <pc:spChg chg="add mod">
          <ac:chgData name="Chichger, Havovi" userId="598738d1-3ba5-4686-aed1-a57cae5413b5" providerId="ADAL" clId="{F3F7A84D-7CA1-42FF-889A-50DC00948B63}" dt="2025-10-17T07:26:13.280" v="76" actId="20577"/>
          <ac:spMkLst>
            <pc:docMk/>
            <pc:sldMk cId="2795855234" sldId="256"/>
            <ac:spMk id="11" creationId="{3D523DD2-1A23-6560-A2A1-3E21E09AD281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2" creationId="{07943C00-DD87-0FFB-B570-E61B23181611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3" creationId="{7701ABEB-D1D0-0058-8A27-F27A1B09995B}"/>
          </ac:spMkLst>
        </pc:spChg>
        <pc:spChg chg="add mod">
          <ac:chgData name="Chichger, Havovi" userId="598738d1-3ba5-4686-aed1-a57cae5413b5" providerId="ADAL" clId="{F3F7A84D-7CA1-42FF-889A-50DC00948B63}" dt="2025-10-17T07:34:34.837" v="385" actId="14100"/>
          <ac:spMkLst>
            <pc:docMk/>
            <pc:sldMk cId="2795855234" sldId="256"/>
            <ac:spMk id="14" creationId="{F6298F77-965B-8FE4-EC41-FDA9B30004C0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5" creationId="{E94CCB00-5910-B017-E66B-4A1C9F6CC18D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6" creationId="{74B9DC2B-8A91-8519-2CD0-B6337C5654B4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7" creationId="{6C717E47-455D-DB17-DC05-D31BE3A5FDF1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8" creationId="{A24A52EC-619D-4827-C55F-9BC438CF66F6}"/>
          </ac:spMkLst>
        </pc:spChg>
        <pc:spChg chg="add mod">
          <ac:chgData name="Chichger, Havovi" userId="598738d1-3ba5-4686-aed1-a57cae5413b5" providerId="ADAL" clId="{F3F7A84D-7CA1-42FF-889A-50DC00948B63}" dt="2025-10-17T07:32:17.982" v="282" actId="1037"/>
          <ac:spMkLst>
            <pc:docMk/>
            <pc:sldMk cId="2795855234" sldId="256"/>
            <ac:spMk id="19" creationId="{AB460355-B356-721C-55FB-5FD48B6A0B16}"/>
          </ac:spMkLst>
        </pc:spChg>
        <pc:spChg chg="add mod">
          <ac:chgData name="Chichger, Havovi" userId="598738d1-3ba5-4686-aed1-a57cae5413b5" providerId="ADAL" clId="{F3F7A84D-7CA1-42FF-889A-50DC00948B63}" dt="2025-10-17T07:34:03.426" v="325" actId="1038"/>
          <ac:spMkLst>
            <pc:docMk/>
            <pc:sldMk cId="2795855234" sldId="256"/>
            <ac:spMk id="22" creationId="{B9DCFCAF-757B-D4EA-4BF4-DC533E598DC3}"/>
          </ac:spMkLst>
        </pc:spChg>
        <pc:spChg chg="add mod">
          <ac:chgData name="Chichger, Havovi" userId="598738d1-3ba5-4686-aed1-a57cae5413b5" providerId="ADAL" clId="{F3F7A84D-7CA1-42FF-889A-50DC00948B63}" dt="2025-10-17T07:33:27.614" v="295" actId="1076"/>
          <ac:spMkLst>
            <pc:docMk/>
            <pc:sldMk cId="2795855234" sldId="256"/>
            <ac:spMk id="23" creationId="{02F2AF9A-D5E9-CDCB-E8E4-244C5E5BE613}"/>
          </ac:spMkLst>
        </pc:spChg>
        <pc:spChg chg="add mod">
          <ac:chgData name="Chichger, Havovi" userId="598738d1-3ba5-4686-aed1-a57cae5413b5" providerId="ADAL" clId="{F3F7A84D-7CA1-42FF-889A-50DC00948B63}" dt="2025-10-17T07:33:32.428" v="303" actId="1036"/>
          <ac:spMkLst>
            <pc:docMk/>
            <pc:sldMk cId="2795855234" sldId="256"/>
            <ac:spMk id="24" creationId="{5491BD47-8EC3-277C-5BEB-A41B69C1C047}"/>
          </ac:spMkLst>
        </pc:spChg>
        <pc:spChg chg="add mod">
          <ac:chgData name="Chichger, Havovi" userId="598738d1-3ba5-4686-aed1-a57cae5413b5" providerId="ADAL" clId="{F3F7A84D-7CA1-42FF-889A-50DC00948B63}" dt="2025-10-17T07:33:36.193" v="309" actId="1038"/>
          <ac:spMkLst>
            <pc:docMk/>
            <pc:sldMk cId="2795855234" sldId="256"/>
            <ac:spMk id="25" creationId="{E8BB916D-B037-E44C-9E84-9E56D137BEE7}"/>
          </ac:spMkLst>
        </pc:spChg>
        <pc:spChg chg="add mod">
          <ac:chgData name="Chichger, Havovi" userId="598738d1-3ba5-4686-aed1-a57cae5413b5" providerId="ADAL" clId="{F3F7A84D-7CA1-42FF-889A-50DC00948B63}" dt="2025-10-17T07:33:36.193" v="309" actId="1038"/>
          <ac:spMkLst>
            <pc:docMk/>
            <pc:sldMk cId="2795855234" sldId="256"/>
            <ac:spMk id="26" creationId="{8B536155-AAF7-C188-58B3-1158FEBFAC3A}"/>
          </ac:spMkLst>
        </pc:spChg>
        <pc:spChg chg="add mod">
          <ac:chgData name="Chichger, Havovi" userId="598738d1-3ba5-4686-aed1-a57cae5413b5" providerId="ADAL" clId="{F3F7A84D-7CA1-42FF-889A-50DC00948B63}" dt="2025-10-17T07:34:17.838" v="343" actId="1038"/>
          <ac:spMkLst>
            <pc:docMk/>
            <pc:sldMk cId="2795855234" sldId="256"/>
            <ac:spMk id="27" creationId="{887597D2-4730-91C0-2F22-B52F46B56358}"/>
          </ac:spMkLst>
        </pc:spChg>
        <pc:spChg chg="add mod">
          <ac:chgData name="Chichger, Havovi" userId="598738d1-3ba5-4686-aed1-a57cae5413b5" providerId="ADAL" clId="{F3F7A84D-7CA1-42FF-889A-50DC00948B63}" dt="2025-10-17T07:34:09.952" v="334" actId="1038"/>
          <ac:spMkLst>
            <pc:docMk/>
            <pc:sldMk cId="2795855234" sldId="256"/>
            <ac:spMk id="28" creationId="{E6BE556E-FB8A-3943-246A-BC660DC729BC}"/>
          </ac:spMkLst>
        </pc:spChg>
        <pc:grpChg chg="add mod">
          <ac:chgData name="Chichger, Havovi" userId="598738d1-3ba5-4686-aed1-a57cae5413b5" providerId="ADAL" clId="{F3F7A84D-7CA1-42FF-889A-50DC00948B63}" dt="2025-10-17T07:32:08.570" v="274" actId="1076"/>
          <ac:grpSpMkLst>
            <pc:docMk/>
            <pc:sldMk cId="2795855234" sldId="256"/>
            <ac:grpSpMk id="20" creationId="{8EB9BFC7-49E6-5A88-C327-32662D7BEC86}"/>
          </ac:grpSpMkLst>
        </pc:grpChg>
        <pc:grpChg chg="add mod">
          <ac:chgData name="Chichger, Havovi" userId="598738d1-3ba5-4686-aed1-a57cae5413b5" providerId="ADAL" clId="{F3F7A84D-7CA1-42FF-889A-50DC00948B63}" dt="2025-10-17T07:32:38.878" v="289" actId="1076"/>
          <ac:grpSpMkLst>
            <pc:docMk/>
            <pc:sldMk cId="2795855234" sldId="256"/>
            <ac:grpSpMk id="21" creationId="{A02EFFD8-DCB2-83DA-A5ED-577AA7AA492E}"/>
          </ac:grpSpMkLst>
        </pc:grpChg>
        <pc:picChg chg="add mod">
          <ac:chgData name="Chichger, Havovi" userId="598738d1-3ba5-4686-aed1-a57cae5413b5" providerId="ADAL" clId="{F3F7A84D-7CA1-42FF-889A-50DC00948B63}" dt="2025-10-17T07:32:24.388" v="283" actId="164"/>
          <ac:picMkLst>
            <pc:docMk/>
            <pc:sldMk cId="2795855234" sldId="256"/>
            <ac:picMk id="5" creationId="{65E8652F-E7F4-F510-8BB7-DF846F207C06}"/>
          </ac:picMkLst>
        </pc:picChg>
        <pc:picChg chg="add mod">
          <ac:chgData name="Chichger, Havovi" userId="598738d1-3ba5-4686-aed1-a57cae5413b5" providerId="ADAL" clId="{F3F7A84D-7CA1-42FF-889A-50DC00948B63}" dt="2025-10-17T07:32:04.178" v="272" actId="164"/>
          <ac:picMkLst>
            <pc:docMk/>
            <pc:sldMk cId="2795855234" sldId="256"/>
            <ac:picMk id="7" creationId="{48BB4E78-3FEB-69E9-8357-AA826EBD6D05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4A3E50-FC4F-5CF2-2879-CCDF62C0B7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A0BCCF1-D47B-5C0F-B851-D6262A8ACBD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7D97F3-1DB1-0B31-2736-73D335014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3B6D0D-DCAC-3576-3628-F10C7AABE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9407F5-69AE-D3ED-926A-5A9A90680E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940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03D3FA-CCA9-2F50-A119-5035DB8098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02668B3-EDF3-61CD-2811-69376AB095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BBB010D-F63B-1D6C-7058-D6501F7226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F17E2-4C5E-D836-D7AF-23283C17B3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E5C0E4-0FB5-CB5D-8F74-47909DF786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5372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0CD553-9C1E-5799-82F9-5BD9CF9B76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4FCC08-4136-8EEF-F822-655E2AB754C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6304A6-A646-4BF1-F8CF-3656D892F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11DE25-A283-7BF4-A1F3-753508A869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A3AFB1-5D88-9CFF-F8D0-4CF4035F2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770551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2062C3-4402-70BC-99FB-15AF711595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9EA6F9-9E3F-5EF8-5A7E-BB366FFC265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B9D662-5C3D-3D4F-0BB8-23BBEA150B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0A38038-5BC0-03A5-4544-487A99ED2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260BD7C-7560-EECA-9C65-BFB7CF79A9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54608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E649A8C-BD73-A3D0-2B8D-3C00FDE868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3E38EB-6879-8B40-7837-F387F8D4B05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1DA285-6149-FDA9-225A-6BE4104C19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F5876E-35AC-DB04-3A09-95F0CDB862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AB0731-AE88-CA04-1231-20B87E16E9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8669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4A2D8C-7A33-DEB8-8DDF-FB696D0D8C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422B872-75FB-0576-84DD-1B1D88ECE96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C1347A-CC61-D045-0467-00BEF5DF25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5D4055-59A9-0CB4-C1DA-D96A4FCB8B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F3E4AB-8A1B-0ED5-604D-2626102F24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0B5083-0FF4-53D6-B1A4-B9AD468A18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992606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85D68D-788D-70B0-0837-660BCA439B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B4DF82-CCA0-A570-1432-049ED38CC3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F5999F-2AF5-12DD-D79F-BFC2A8AE2A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B26C26-FB85-A832-6C06-6EFBC7BCF8B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C2BEDB-D1D3-44DD-5105-18AAA8E52B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72D973F-ADB4-0029-81AE-933FCCE1B3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77EF5AA-580E-8F35-ED89-C062823685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D4999D-5AA7-99B3-BC5A-441EF7EBB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3202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D57B58-7B9E-F3A6-D053-68845DBDD1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696B9C5-181B-EEA6-0A47-E2F56525B0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EDF63B-9007-6100-73A3-B511DAE70E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92E1F7D-553E-8A8D-D4DD-01E130C151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28112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9CE126F-EBD0-042B-505A-59C42EA6C3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3545829-61A2-6938-43C4-CC2F3003B6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10348B-CF4F-7C18-7B9B-5452009A50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17512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4BA704-4A2B-705D-8290-17732C1F04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23CCFE-DA58-7ED0-D3FC-ECEAB5765CF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4334C7-92E6-FE74-815D-DBBB42D412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2FB6E0-9762-44CC-5514-B4A88191E9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BCD615-DAC3-FBB8-B138-409B073F8D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E4C68C4-F5D5-9B5A-5F3B-9256CE20D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12134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AEE21BB-3A57-9AAC-68E4-FF9F52FFCF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A957CE1-82D0-EE86-A71C-45A840F6D9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A747EB-0FE5-2D8C-6A7A-78A3FB61A8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D17CAD1-8057-EE02-FD0D-D651C5380C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079319F-9F96-9939-AD9C-D98749F470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607E6FA-44EB-2868-75E9-A8A51F75B2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98809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4628662-584D-742A-E8D2-5F8230F49C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E03D0E-39EB-17E5-E6C2-686468C4AF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070B9-8B6B-A36C-D2EF-26E3F38035A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C732B2C-A6B9-426F-92F6-BE3607144DFE}" type="datetimeFigureOut">
              <a:rPr lang="en-GB" smtClean="0"/>
              <a:t>07/11/2025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A8AE6B-617B-9DA4-E3C9-E11D8B1413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93B66D-2175-B2D0-1E2D-56994406BE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50C6DB3-9904-4548-A1FA-A9FCCA50B14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803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" name="Group 20">
            <a:extLst>
              <a:ext uri="{FF2B5EF4-FFF2-40B4-BE49-F238E27FC236}">
                <a16:creationId xmlns:a16="http://schemas.microsoft.com/office/drawing/2014/main" id="{A02EFFD8-DCB2-83DA-A5ED-577AA7AA492E}"/>
              </a:ext>
            </a:extLst>
          </p:cNvPr>
          <p:cNvGrpSpPr/>
          <p:nvPr/>
        </p:nvGrpSpPr>
        <p:grpSpPr>
          <a:xfrm>
            <a:off x="7306573" y="1449237"/>
            <a:ext cx="3856007" cy="3289584"/>
            <a:chOff x="6644417" y="1135768"/>
            <a:chExt cx="5291666" cy="4405311"/>
          </a:xfrm>
        </p:grpSpPr>
        <p:pic>
          <p:nvPicPr>
            <p:cNvPr id="5" name="Picture 4" descr="A close-up of a test&#10;&#10;AI-generated content may be incorrect.">
              <a:extLst>
                <a:ext uri="{FF2B5EF4-FFF2-40B4-BE49-F238E27FC236}">
                  <a16:creationId xmlns:a16="http://schemas.microsoft.com/office/drawing/2014/main" id="{65E8652F-E7F4-F510-8BB7-DF846F207C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44417" y="1135768"/>
              <a:ext cx="5291666" cy="4405311"/>
            </a:xfrm>
            <a:prstGeom prst="rect">
              <a:avLst/>
            </a:prstGeom>
          </p:spPr>
        </p:pic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161CD4FF-BDE5-35E9-775D-2E48F2EBBA12}"/>
                </a:ext>
              </a:extLst>
            </p:cNvPr>
            <p:cNvSpPr/>
            <p:nvPr/>
          </p:nvSpPr>
          <p:spPr>
            <a:xfrm>
              <a:off x="7683261" y="2541918"/>
              <a:ext cx="934528" cy="322052"/>
            </a:xfrm>
            <a:prstGeom prst="rect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CE75EA26-D31C-681F-379A-CE0DFF2CDC4F}"/>
              </a:ext>
            </a:extLst>
          </p:cNvPr>
          <p:cNvSpPr txBox="1"/>
          <p:nvPr/>
        </p:nvSpPr>
        <p:spPr>
          <a:xfrm>
            <a:off x="839245" y="724619"/>
            <a:ext cx="505259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2a i: T1R3 blot for Caco2 cell lysates (red box denotes top panel on figure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D523DD2-1A23-6560-A2A1-3E21E09AD281}"/>
              </a:ext>
            </a:extLst>
          </p:cNvPr>
          <p:cNvSpPr txBox="1"/>
          <p:nvPr/>
        </p:nvSpPr>
        <p:spPr>
          <a:xfrm>
            <a:off x="7113917" y="724619"/>
            <a:ext cx="453749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Figure 2a: Actin blot for Caco2 cell lysates (red </a:t>
            </a:r>
            <a:r>
              <a:rPr lang="en-GB" b="1"/>
              <a:t>box denotes bottom </a:t>
            </a:r>
            <a:r>
              <a:rPr lang="en-GB" b="1" dirty="0"/>
              <a:t>panel on figure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6298F77-965B-8FE4-EC41-FDA9B30004C0}"/>
              </a:ext>
            </a:extLst>
          </p:cNvPr>
          <p:cNvSpPr txBox="1"/>
          <p:nvPr/>
        </p:nvSpPr>
        <p:spPr>
          <a:xfrm>
            <a:off x="3623094" y="5184364"/>
            <a:ext cx="7303699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Lanes 1B N, 1B H, 3B H = T1R3 siRNA treat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Lanes 4B H, 3B N, 2A N, 1A H = ns siRNA treatment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Lanes 2B N, 4A H, 4A N, 2A H, 3A N = various positive controls for T1R3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/>
              <a:t>Ladder – dual Xtra Standards </a:t>
            </a:r>
            <a:r>
              <a:rPr lang="en-GB" sz="1600" dirty="0" err="1"/>
              <a:t>BioRad</a:t>
            </a:r>
            <a:endParaRPr lang="en-GB" sz="1600" dirty="0"/>
          </a:p>
        </p:txBody>
      </p:sp>
      <p:grpSp>
        <p:nvGrpSpPr>
          <p:cNvPr id="20" name="Group 19">
            <a:extLst>
              <a:ext uri="{FF2B5EF4-FFF2-40B4-BE49-F238E27FC236}">
                <a16:creationId xmlns:a16="http://schemas.microsoft.com/office/drawing/2014/main" id="{8EB9BFC7-49E6-5A88-C327-32662D7BEC86}"/>
              </a:ext>
            </a:extLst>
          </p:cNvPr>
          <p:cNvGrpSpPr/>
          <p:nvPr/>
        </p:nvGrpSpPr>
        <p:grpSpPr>
          <a:xfrm>
            <a:off x="649868" y="1449237"/>
            <a:ext cx="4897716" cy="3289584"/>
            <a:chOff x="104834" y="1135767"/>
            <a:chExt cx="6388771" cy="4405311"/>
          </a:xfrm>
        </p:grpSpPr>
        <p:pic>
          <p:nvPicPr>
            <p:cNvPr id="7" name="Picture 6" descr="A close-up of a test&#10;&#10;AI-generated content may be incorrect.">
              <a:extLst>
                <a:ext uri="{FF2B5EF4-FFF2-40B4-BE49-F238E27FC236}">
                  <a16:creationId xmlns:a16="http://schemas.microsoft.com/office/drawing/2014/main" id="{48BB4E78-3FEB-69E9-8357-AA826EBD6D0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20301" y="1135767"/>
              <a:ext cx="5973304" cy="4405311"/>
            </a:xfrm>
            <a:prstGeom prst="rect">
              <a:avLst/>
            </a:prstGeom>
          </p:spPr>
        </p:pic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0FBB7439-8996-A3F8-5637-13A5484CD678}"/>
                </a:ext>
              </a:extLst>
            </p:cNvPr>
            <p:cNvSpPr/>
            <p:nvPr/>
          </p:nvSpPr>
          <p:spPr>
            <a:xfrm>
              <a:off x="1794294" y="2863970"/>
              <a:ext cx="905773" cy="414069"/>
            </a:xfrm>
            <a:prstGeom prst="rect">
              <a:avLst/>
            </a:prstGeom>
            <a:noFill/>
            <a:ln w="5715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sz="1200"/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07943C00-DD87-0FFB-B570-E61B23181611}"/>
                </a:ext>
              </a:extLst>
            </p:cNvPr>
            <p:cNvSpPr txBox="1"/>
            <p:nvPr/>
          </p:nvSpPr>
          <p:spPr>
            <a:xfrm>
              <a:off x="104834" y="2768600"/>
              <a:ext cx="520302" cy="3400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100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7701ABEB-D1D0-0058-8A27-F27A1B09995B}"/>
                </a:ext>
              </a:extLst>
            </p:cNvPr>
            <p:cNvSpPr txBox="1"/>
            <p:nvPr/>
          </p:nvSpPr>
          <p:spPr>
            <a:xfrm>
              <a:off x="174333" y="3087417"/>
              <a:ext cx="520302" cy="3297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75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E94CCB00-5910-B017-E66B-4A1C9F6CC18D}"/>
                </a:ext>
              </a:extLst>
            </p:cNvPr>
            <p:cNvSpPr txBox="1"/>
            <p:nvPr/>
          </p:nvSpPr>
          <p:spPr>
            <a:xfrm>
              <a:off x="174332" y="3535402"/>
              <a:ext cx="520302" cy="3297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50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74B9DC2B-8A91-8519-2CD0-B6337C5654B4}"/>
                </a:ext>
              </a:extLst>
            </p:cNvPr>
            <p:cNvSpPr txBox="1"/>
            <p:nvPr/>
          </p:nvSpPr>
          <p:spPr>
            <a:xfrm>
              <a:off x="179119" y="4163703"/>
              <a:ext cx="520302" cy="3297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37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6C717E47-455D-DB17-DC05-D31BE3A5FDF1}"/>
                </a:ext>
              </a:extLst>
            </p:cNvPr>
            <p:cNvSpPr txBox="1"/>
            <p:nvPr/>
          </p:nvSpPr>
          <p:spPr>
            <a:xfrm>
              <a:off x="179119" y="4982508"/>
              <a:ext cx="520302" cy="3297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25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A24A52EC-619D-4827-C55F-9BC438CF66F6}"/>
                </a:ext>
              </a:extLst>
            </p:cNvPr>
            <p:cNvSpPr txBox="1"/>
            <p:nvPr/>
          </p:nvSpPr>
          <p:spPr>
            <a:xfrm>
              <a:off x="122574" y="2470694"/>
              <a:ext cx="520302" cy="3400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150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AB460355-B356-721C-55FB-5FD48B6A0B16}"/>
                </a:ext>
              </a:extLst>
            </p:cNvPr>
            <p:cNvSpPr txBox="1"/>
            <p:nvPr/>
          </p:nvSpPr>
          <p:spPr>
            <a:xfrm>
              <a:off x="131201" y="2217959"/>
              <a:ext cx="520302" cy="34003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000" dirty="0"/>
                <a:t>250</a:t>
              </a:r>
            </a:p>
          </p:txBody>
        </p:sp>
      </p:grpSp>
      <p:sp>
        <p:nvSpPr>
          <p:cNvPr id="22" name="TextBox 21">
            <a:extLst>
              <a:ext uri="{FF2B5EF4-FFF2-40B4-BE49-F238E27FC236}">
                <a16:creationId xmlns:a16="http://schemas.microsoft.com/office/drawing/2014/main" id="{B9DCFCAF-757B-D4EA-4BF4-DC533E598DC3}"/>
              </a:ext>
            </a:extLst>
          </p:cNvPr>
          <p:cNvSpPr txBox="1"/>
          <p:nvPr/>
        </p:nvSpPr>
        <p:spPr>
          <a:xfrm>
            <a:off x="7038594" y="3284377"/>
            <a:ext cx="3988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20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2F2AF9A-D5E9-CDCB-E8E4-244C5E5BE613}"/>
              </a:ext>
            </a:extLst>
          </p:cNvPr>
          <p:cNvSpPr txBox="1"/>
          <p:nvPr/>
        </p:nvSpPr>
        <p:spPr>
          <a:xfrm>
            <a:off x="7032645" y="2271630"/>
            <a:ext cx="398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7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491BD47-8EC3-277C-5BEB-A41B69C1C047}"/>
              </a:ext>
            </a:extLst>
          </p:cNvPr>
          <p:cNvSpPr txBox="1"/>
          <p:nvPr/>
        </p:nvSpPr>
        <p:spPr>
          <a:xfrm>
            <a:off x="7047604" y="2409267"/>
            <a:ext cx="398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50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8BB916D-B037-E44C-9E84-9E56D137BEE7}"/>
              </a:ext>
            </a:extLst>
          </p:cNvPr>
          <p:cNvSpPr txBox="1"/>
          <p:nvPr/>
        </p:nvSpPr>
        <p:spPr>
          <a:xfrm>
            <a:off x="7047604" y="2739739"/>
            <a:ext cx="398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37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B536155-AAF7-C188-58B3-1158FEBFAC3A}"/>
              </a:ext>
            </a:extLst>
          </p:cNvPr>
          <p:cNvSpPr txBox="1"/>
          <p:nvPr/>
        </p:nvSpPr>
        <p:spPr>
          <a:xfrm>
            <a:off x="7048457" y="2980905"/>
            <a:ext cx="3988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25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87597D2-4730-91C0-2F22-B52F46B56358}"/>
              </a:ext>
            </a:extLst>
          </p:cNvPr>
          <p:cNvSpPr txBox="1"/>
          <p:nvPr/>
        </p:nvSpPr>
        <p:spPr>
          <a:xfrm>
            <a:off x="7046662" y="4299331"/>
            <a:ext cx="3988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10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6BE556E-FB8A-3943-246A-BC660DC729BC}"/>
              </a:ext>
            </a:extLst>
          </p:cNvPr>
          <p:cNvSpPr txBox="1"/>
          <p:nvPr/>
        </p:nvSpPr>
        <p:spPr>
          <a:xfrm>
            <a:off x="7041342" y="3710292"/>
            <a:ext cx="39887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00" dirty="0"/>
              <a:t>15</a:t>
            </a:r>
          </a:p>
        </p:txBody>
      </p:sp>
    </p:spTree>
    <p:extLst>
      <p:ext uri="{BB962C8B-B14F-4D97-AF65-F5344CB8AC3E}">
        <p14:creationId xmlns:p14="http://schemas.microsoft.com/office/powerpoint/2010/main" val="27958552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5f35c3da-39ae-4632-9ac1-afc2f25d2852}" enabled="0" method="" siteId="{5f35c3da-39ae-4632-9ac1-afc2f25d285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50</TotalTime>
  <Words>107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ichger, Havovi</dc:creator>
  <cp:lastModifiedBy>Chichger, Havovi</cp:lastModifiedBy>
  <cp:revision>1</cp:revision>
  <dcterms:created xsi:type="dcterms:W3CDTF">2025-10-17T07:12:26Z</dcterms:created>
  <dcterms:modified xsi:type="dcterms:W3CDTF">2025-11-07T14:24:26Z</dcterms:modified>
</cp:coreProperties>
</file>